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9" d="100"/>
          <a:sy n="79" d="100"/>
        </p:scale>
        <p:origin x="-2622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83E634-558B-4A68-B636-A74AB23B2438}" type="datetimeFigureOut">
              <a:rPr lang="fr-FR" smtClean="0"/>
              <a:t>25/05/201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DF4996-086F-4080-8C26-57D685D5700B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au 3"/>
          <p:cNvGraphicFramePr>
            <a:graphicFrameLocks noGrp="1"/>
          </p:cNvGraphicFramePr>
          <p:nvPr/>
        </p:nvGraphicFramePr>
        <p:xfrm>
          <a:off x="836709" y="827647"/>
          <a:ext cx="5256586" cy="14996160"/>
        </p:xfrm>
        <a:graphic>
          <a:graphicData uri="http://schemas.openxmlformats.org/drawingml/2006/table">
            <a:tbl>
              <a:tblPr/>
              <a:tblGrid>
                <a:gridCol w="583742"/>
                <a:gridCol w="335075"/>
                <a:gridCol w="335075"/>
                <a:gridCol w="335075"/>
                <a:gridCol w="335075"/>
                <a:gridCol w="356825"/>
                <a:gridCol w="2142731"/>
                <a:gridCol w="832988"/>
              </a:tblGrid>
              <a:tr h="88482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 dirty="0" err="1">
                          <a:latin typeface="Garamond"/>
                          <a:ea typeface="Times New Roman"/>
                          <a:cs typeface="Arial"/>
                        </a:rPr>
                        <a:t>DNMTs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Lung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Liver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Kidney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Heart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Placenta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Gene name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Accession number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 dirty="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8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0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5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Dnmt3a-ps2 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AB19134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11,3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7,0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Dnmt3a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C08991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7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4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Dnmt3a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0100395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 dirty="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3,1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3,1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Dnmt3b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0100395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 dirty="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3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1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7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4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Dnmt3l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0100396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3,38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0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8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7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Dnmt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0103164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-1,82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Dnmt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5335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5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3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7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similar to Dnmt3a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00106949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-1,45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3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58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Grhl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3400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 dirty="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HDACs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Lung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 dirty="0" err="1">
                          <a:latin typeface="Garamond"/>
                          <a:ea typeface="Times New Roman"/>
                          <a:cs typeface="Arial"/>
                        </a:rPr>
                        <a:t>Liver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Kidney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Heart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Placenta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5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-1,11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Hdac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C06198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6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-1,10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1,08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Hdac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C08643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4,8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2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1,29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Hdac1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C09257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-1,08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3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Hdac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C10747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-1,09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3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Hdac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0102540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5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1,06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3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Hdac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5344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1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7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-1,08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Hdac7a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00105479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4,2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8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-1,14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Hdac1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00107345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9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-1,10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3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Hdac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2875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9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8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-1,09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Hdac1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3836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8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Hdac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34214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8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23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Hdac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34362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9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4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1,65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Hdac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34380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8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5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1,06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Hdac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57659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CHD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 dirty="0">
                          <a:latin typeface="Garamond"/>
                          <a:ea typeface="Times New Roman"/>
                          <a:cs typeface="Arial"/>
                        </a:rPr>
                        <a:t>Lung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Liver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Kidney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Heart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Placenta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8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1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7,0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Chd8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AF16982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9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4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1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latin typeface="Garamond"/>
                          <a:ea typeface="Times New Roman"/>
                          <a:cs typeface="Arial"/>
                        </a:rPr>
                        <a:t>similar to testis-specific chromodomain Y-like protein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0101414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6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5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Chd4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00106786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3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3,5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5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3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600" dirty="0">
                          <a:latin typeface="Garamond"/>
                          <a:ea typeface="Times New Roman"/>
                          <a:cs typeface="Arial"/>
                        </a:rPr>
                        <a:t>similar to </a:t>
                      </a:r>
                      <a:r>
                        <a:rPr lang="en-US" sz="600" dirty="0" err="1">
                          <a:latin typeface="Garamond"/>
                          <a:ea typeface="Times New Roman"/>
                          <a:cs typeface="Arial"/>
                        </a:rPr>
                        <a:t>chromodomain</a:t>
                      </a:r>
                      <a:r>
                        <a:rPr lang="en-US" sz="600" dirty="0">
                          <a:latin typeface="Garamond"/>
                          <a:ea typeface="Times New Roman"/>
                          <a:cs typeface="Arial"/>
                        </a:rPr>
                        <a:t> </a:t>
                      </a:r>
                      <a:r>
                        <a:rPr lang="en-US" sz="600" dirty="0" err="1">
                          <a:latin typeface="Garamond"/>
                          <a:ea typeface="Times New Roman"/>
                          <a:cs typeface="Arial"/>
                        </a:rPr>
                        <a:t>helicase</a:t>
                      </a:r>
                      <a:r>
                        <a:rPr lang="en-US" sz="600" dirty="0">
                          <a:latin typeface="Garamond"/>
                          <a:ea typeface="Times New Roman"/>
                          <a:cs typeface="Arial"/>
                        </a:rPr>
                        <a:t> DNA binding protein 5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00107894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741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3,0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5,2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0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latin typeface="Garamond"/>
                          <a:ea typeface="Times New Roman"/>
                          <a:cs typeface="Arial"/>
                        </a:rPr>
                        <a:t>similar to Probable chromodomain-helicase-DNA-binding protein KIAA141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00107958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3,6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8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Chd2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1879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5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4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d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2060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0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4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8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600" dirty="0">
                          <a:latin typeface="Garamond"/>
                          <a:ea typeface="Times New Roman"/>
                          <a:cs typeface="Arial"/>
                        </a:rPr>
                        <a:t> similar to </a:t>
                      </a:r>
                      <a:r>
                        <a:rPr lang="en-US" sz="600" dirty="0" err="1">
                          <a:latin typeface="Garamond"/>
                          <a:ea typeface="Times New Roman"/>
                          <a:cs typeface="Arial"/>
                        </a:rPr>
                        <a:t>Chromodomain</a:t>
                      </a:r>
                      <a:r>
                        <a:rPr lang="en-US" sz="600" dirty="0">
                          <a:latin typeface="Garamond"/>
                          <a:ea typeface="Times New Roman"/>
                          <a:cs typeface="Arial"/>
                        </a:rPr>
                        <a:t>-</a:t>
                      </a:r>
                      <a:r>
                        <a:rPr lang="en-US" sz="600" dirty="0" err="1">
                          <a:latin typeface="Garamond"/>
                          <a:ea typeface="Times New Roman"/>
                          <a:cs typeface="Arial"/>
                        </a:rPr>
                        <a:t>helicase</a:t>
                      </a:r>
                      <a:r>
                        <a:rPr lang="en-US" sz="600" dirty="0">
                          <a:latin typeface="Garamond"/>
                          <a:ea typeface="Times New Roman"/>
                          <a:cs typeface="Arial"/>
                        </a:rPr>
                        <a:t>-DNA-binding protein 1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2080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7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5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dyl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2651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2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4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3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600" dirty="0">
                          <a:latin typeface="Garamond"/>
                          <a:ea typeface="Times New Roman"/>
                          <a:cs typeface="Arial"/>
                        </a:rPr>
                        <a:t>similar to </a:t>
                      </a:r>
                      <a:r>
                        <a:rPr lang="en-US" sz="600" dirty="0" err="1">
                          <a:latin typeface="Garamond"/>
                          <a:ea typeface="Times New Roman"/>
                          <a:cs typeface="Arial"/>
                        </a:rPr>
                        <a:t>chromodomain</a:t>
                      </a:r>
                      <a:r>
                        <a:rPr lang="en-US" sz="600" dirty="0">
                          <a:latin typeface="Garamond"/>
                          <a:ea typeface="Times New Roman"/>
                          <a:cs typeface="Arial"/>
                        </a:rPr>
                        <a:t> Y-like protein 2 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2651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5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4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4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d1l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2751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Chd6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3081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3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4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latin typeface="Garamond"/>
                          <a:ea typeface="Times New Roman"/>
                          <a:cs typeface="Arial"/>
                        </a:rPr>
                        <a:t> similar to chromodomain protein, Y chromosome-like isoform a 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3145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3,4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9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Chd7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3267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9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7,9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Chd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3873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5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Chd8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57376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BRD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Lung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Liver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Kidney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Heart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Placenta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7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9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8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8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 err="1">
                          <a:latin typeface="Garamond"/>
                          <a:ea typeface="Times New Roman"/>
                          <a:cs typeface="Arial"/>
                        </a:rPr>
                        <a:t>Brdt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C07899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9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6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3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6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rd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0100850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rd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21249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741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latin typeface="Garamond"/>
                          <a:ea typeface="Times New Roman"/>
                          <a:cs typeface="Arial"/>
                        </a:rPr>
                        <a:t>similar to bromodomain and PHD finger-containing protein 1 isoform 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00105415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0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3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9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rd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00106592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6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5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Brd9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1774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1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5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4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8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latin typeface="Garamond"/>
                          <a:ea typeface="Times New Roman"/>
                          <a:cs typeface="Arial"/>
                        </a:rPr>
                        <a:t>similar to bromodomain and WD repeat domain containing 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1937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-1,13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1,04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1,13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7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rwd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2162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6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5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9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az2a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2231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3,2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Brpf3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2803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9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3,2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rwd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2851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9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3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7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4,6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az2b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2922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5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0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Baz1a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3415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6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6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rd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3555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rd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34165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5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Brd3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34239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4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3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az1b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34716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3,5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5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Brdt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57354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741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Histone methyl/acetyl transferase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Lung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Liver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Kidney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Heart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i="1">
                          <a:latin typeface="Garamond"/>
                          <a:ea typeface="Times New Roman"/>
                          <a:cs typeface="Arial"/>
                        </a:rPr>
                        <a:t>Placenta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 dirty="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0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5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Myst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AY24145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6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3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6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Hat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0100965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6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3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6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Myst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00101737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4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Myst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NM_18108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7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Ehmt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NM_212463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8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9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latin typeface="Garamond"/>
                          <a:ea typeface="Times New Roman"/>
                          <a:cs typeface="Arial"/>
                        </a:rPr>
                        <a:t>similar to Histone acetyltransferase MYST4 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00106769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6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3,6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3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2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latin typeface="Garamond"/>
                          <a:ea typeface="Times New Roman"/>
                          <a:cs typeface="Arial"/>
                        </a:rPr>
                        <a:t>similar to Histone-lysine N-methyltransferase, H3 lysine-9 specific 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XM_001072340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1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2,8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9C0006"/>
                          </a:solidFill>
                          <a:latin typeface="Garamond"/>
                          <a:ea typeface="Times New Roman"/>
                          <a:cs typeface="Arial"/>
                        </a:rPr>
                        <a:t>4,0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C7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latin typeface="Garamond"/>
                          <a:ea typeface="Times New Roman"/>
                          <a:cs typeface="Arial"/>
                        </a:rPr>
                        <a:t>similar to Histone-lysine N-methyltransferase, H3 lysine-9 specific 4 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00107237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741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3,2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7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2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5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600">
                          <a:latin typeface="Garamond"/>
                          <a:ea typeface="Times New Roman"/>
                          <a:cs typeface="Arial"/>
                        </a:rPr>
                        <a:t>similar to Histone-lysine N-methyltransferase, H3 lysine-4 specific SET7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00107267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4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1,03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7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Myst3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XM_22500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2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00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46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Ehmt1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XM_342379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0225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fr-FR" sz="600">
                        <a:latin typeface="Garamond"/>
                        <a:ea typeface="Times New Roman"/>
                        <a:cs typeface="Arial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solidFill>
                            <a:srgbClr val="006100"/>
                          </a:solidFill>
                          <a:latin typeface="Garamond"/>
                          <a:ea typeface="Times New Roman"/>
                          <a:cs typeface="Arial"/>
                        </a:rPr>
                        <a:t>-2,34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EFCE"/>
                    </a:solidFill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15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8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-1,09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1,42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>
                          <a:latin typeface="Garamond"/>
                          <a:ea typeface="Times New Roman"/>
                          <a:cs typeface="Arial"/>
                        </a:rPr>
                        <a:t>Dot1l</a:t>
                      </a:r>
                      <a:endParaRPr lang="fr-FR" sz="6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fr-FR" sz="600" dirty="0">
                          <a:latin typeface="Garamond"/>
                          <a:ea typeface="Times New Roman"/>
                          <a:cs typeface="Arial"/>
                        </a:rPr>
                        <a:t>XM_343159</a:t>
                      </a:r>
                      <a:endParaRPr lang="fr-FR" sz="6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9146" marR="9146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  <p:sp>
        <p:nvSpPr>
          <p:cNvPr id="3074" name="Rectangle 2"/>
          <p:cNvSpPr>
            <a:spLocks noChangeArrowheads="1"/>
          </p:cNvSpPr>
          <p:nvPr/>
        </p:nvSpPr>
        <p:spPr bwMode="auto">
          <a:xfrm>
            <a:off x="0" y="251520"/>
            <a:ext cx="6858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Garamond" pitchFamily="18" charset="0"/>
                <a:ea typeface="Calibri" pitchFamily="34" charset="0"/>
                <a:cs typeface="Times New Roman" pitchFamily="18" charset="0"/>
              </a:rPr>
              <a:t>Supplementary Table I: list of epigenetic regulators and their degree of alterations by induced IUGR in the rat model.</a:t>
            </a:r>
            <a:endParaRPr kumimoji="0" lang="fr-FR" sz="5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Garamond" pitchFamily="18" charset="0"/>
                <a:ea typeface="Calibri" pitchFamily="34" charset="0"/>
                <a:cs typeface="Times New Roman" pitchFamily="18" charset="0"/>
              </a:rPr>
              <a:t/>
            </a:r>
            <a:br>
              <a:rPr kumimoji="0" lang="en-US" sz="11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Garamond" pitchFamily="18" charset="0"/>
                <a:ea typeface="Calibri" pitchFamily="34" charset="0"/>
                <a:cs typeface="Times New Roman" pitchFamily="18" charset="0"/>
              </a:rPr>
            </a:br>
            <a:endParaRPr kumimoji="0" lang="en-US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18</Words>
  <Application>Microsoft Office PowerPoint</Application>
  <PresentationFormat>Affichage à l'écran (4:3)</PresentationFormat>
  <Paragraphs>51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Daniel</dc:creator>
  <cp:lastModifiedBy>Daniel</cp:lastModifiedBy>
  <cp:revision>5</cp:revision>
  <dcterms:created xsi:type="dcterms:W3CDTF">2011-05-25T16:59:47Z</dcterms:created>
  <dcterms:modified xsi:type="dcterms:W3CDTF">2011-05-25T17:01:21Z</dcterms:modified>
</cp:coreProperties>
</file>